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E4C3F2-1E4D-48B9-9CAA-E9C016C7FE6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82AE92-4EA8-403E-B8CD-4F83A848DF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8C9CE3-5DB9-43F2-AB4D-7F345BE2A0F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8B95C6-5D56-4F80-B3AC-A298001B067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40659E-63B3-4C64-B8E8-493FA204ACE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6EBDB6-976C-49B2-93AF-EAB5CEAADB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5304FC-EEE1-411B-A2B8-2AB79875674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95556B-C5FA-4348-84E0-F4F357E2FCD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2092B8-E73A-466F-A55C-5EB8BDD54D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7790DE-D09A-41B5-BD73-8EB4E7D4BE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592D5D-C403-41D5-BEE8-43D1FF784F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E70FA8-199C-4258-92D4-39961C3B6F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0B567A7-369C-4AE3-A296-C9B58666020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6705720" y="2133720"/>
            <a:ext cx="380880" cy="1295280"/>
          </a:xfrm>
          <a:custGeom>
            <a:avLst/>
            <a:gdLst>
              <a:gd name="textAreaLeft" fmla="*/ 0 w 380880"/>
              <a:gd name="textAreaRight" fmla="*/ 137520 w 380880"/>
              <a:gd name="textAreaTop" fmla="*/ 33480 h 1295280"/>
              <a:gd name="textAreaBottom" fmla="*/ 1261800 h 12952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8160" y="1181160"/>
            <a:ext cx="2057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7K genes DATASE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199960" y="1231920"/>
            <a:ext cx="154620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re vs Post treatme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air T test pvalue&lt;0.0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2591640" y="3174840"/>
            <a:ext cx="79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99cc00"/>
                </a:solidFill>
                <a:latin typeface="Arial"/>
              </a:rPr>
              <a:t>650 gen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591640" y="3778200"/>
            <a:ext cx="792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cc66"/>
                </a:solidFill>
                <a:latin typeface="Arial"/>
              </a:rPr>
              <a:t>495 gen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591640" y="1981080"/>
            <a:ext cx="861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ff6600"/>
                </a:solidFill>
                <a:latin typeface="Arial"/>
              </a:rPr>
              <a:t>1311 gen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7" name=""/>
          <p:cNvGrpSpPr/>
          <p:nvPr/>
        </p:nvGrpSpPr>
        <p:grpSpPr>
          <a:xfrm>
            <a:off x="383040" y="1720800"/>
            <a:ext cx="1553400" cy="547920"/>
            <a:chOff x="383040" y="1720800"/>
            <a:chExt cx="1553400" cy="547920"/>
          </a:xfrm>
        </p:grpSpPr>
        <p:sp>
          <p:nvSpPr>
            <p:cNvPr id="48" name=""/>
            <p:cNvSpPr/>
            <p:nvPr/>
          </p:nvSpPr>
          <p:spPr>
            <a:xfrm>
              <a:off x="434520" y="2022480"/>
              <a:ext cx="587520" cy="246240"/>
            </a:xfrm>
            <a:prstGeom prst="rect">
              <a:avLst/>
            </a:prstGeom>
            <a:solidFill>
              <a:srgbClr val="ff9933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q12,2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1348920" y="2022480"/>
              <a:ext cx="587520" cy="246240"/>
            </a:xfrm>
            <a:prstGeom prst="rect">
              <a:avLst/>
            </a:prstGeom>
            <a:solidFill>
              <a:srgbClr val="ff9933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q12,2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83040" y="1720800"/>
              <a:ext cx="439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R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1206360" y="1720800"/>
              <a:ext cx="525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OS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2" name=""/>
          <p:cNvSpPr/>
          <p:nvPr/>
        </p:nvSpPr>
        <p:spPr>
          <a:xfrm>
            <a:off x="2591640" y="2571840"/>
            <a:ext cx="861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9999"/>
                </a:solidFill>
                <a:latin typeface="Arial"/>
              </a:rPr>
              <a:t>1578 gene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3" name=""/>
          <p:cNvGrpSpPr/>
          <p:nvPr/>
        </p:nvGrpSpPr>
        <p:grpSpPr>
          <a:xfrm>
            <a:off x="408600" y="2298600"/>
            <a:ext cx="1528200" cy="547920"/>
            <a:chOff x="408600" y="2298600"/>
            <a:chExt cx="1528200" cy="547920"/>
          </a:xfrm>
        </p:grpSpPr>
        <p:sp>
          <p:nvSpPr>
            <p:cNvPr id="54" name=""/>
            <p:cNvSpPr/>
            <p:nvPr/>
          </p:nvSpPr>
          <p:spPr>
            <a:xfrm>
              <a:off x="434880" y="2600280"/>
              <a:ext cx="587520" cy="246240"/>
            </a:xfrm>
            <a:prstGeom prst="rect">
              <a:avLst/>
            </a:prstGeom>
            <a:solidFill>
              <a:srgbClr val="009999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q12,4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1349280" y="2600280"/>
              <a:ext cx="587520" cy="246240"/>
            </a:xfrm>
            <a:prstGeom prst="rect">
              <a:avLst/>
            </a:prstGeom>
            <a:solidFill>
              <a:srgbClr val="009999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q12,4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408600" y="2298600"/>
              <a:ext cx="439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R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1231920" y="2298600"/>
              <a:ext cx="525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OS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8" name=""/>
          <p:cNvGrpSpPr/>
          <p:nvPr/>
        </p:nvGrpSpPr>
        <p:grpSpPr>
          <a:xfrm>
            <a:off x="397440" y="2908440"/>
            <a:ext cx="1539360" cy="547560"/>
            <a:chOff x="397440" y="2908440"/>
            <a:chExt cx="1539360" cy="547560"/>
          </a:xfrm>
        </p:grpSpPr>
        <p:sp>
          <p:nvSpPr>
            <p:cNvPr id="59" name=""/>
            <p:cNvSpPr/>
            <p:nvPr/>
          </p:nvSpPr>
          <p:spPr>
            <a:xfrm>
              <a:off x="434880" y="3209760"/>
              <a:ext cx="587520" cy="246240"/>
            </a:xfrm>
            <a:prstGeom prst="rect">
              <a:avLst/>
            </a:prstGeom>
            <a:solidFill>
              <a:srgbClr val="99cc0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q24,4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1349280" y="3209760"/>
              <a:ext cx="587520" cy="246240"/>
            </a:xfrm>
            <a:prstGeom prst="rect">
              <a:avLst/>
            </a:prstGeom>
            <a:solidFill>
              <a:srgbClr val="99cc0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q24,4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397440" y="2908440"/>
              <a:ext cx="439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R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1263600" y="2908440"/>
              <a:ext cx="525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OS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3" name=""/>
          <p:cNvGrpSpPr/>
          <p:nvPr/>
        </p:nvGrpSpPr>
        <p:grpSpPr>
          <a:xfrm>
            <a:off x="434520" y="3473280"/>
            <a:ext cx="1501920" cy="547920"/>
            <a:chOff x="434520" y="3473280"/>
            <a:chExt cx="1501920" cy="547920"/>
          </a:xfrm>
        </p:grpSpPr>
        <p:sp>
          <p:nvSpPr>
            <p:cNvPr id="64" name=""/>
            <p:cNvSpPr/>
            <p:nvPr/>
          </p:nvSpPr>
          <p:spPr>
            <a:xfrm>
              <a:off x="434520" y="3774960"/>
              <a:ext cx="587520" cy="246240"/>
            </a:xfrm>
            <a:prstGeom prst="rect">
              <a:avLst/>
            </a:prstGeom>
            <a:solidFill>
              <a:srgbClr val="ffcc66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q24,8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1348920" y="3774960"/>
              <a:ext cx="587520" cy="246240"/>
            </a:xfrm>
            <a:prstGeom prst="rect">
              <a:avLst/>
            </a:prstGeom>
            <a:solidFill>
              <a:srgbClr val="ffcc66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q24,8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435240" y="3473280"/>
              <a:ext cx="439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R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1272960" y="3473280"/>
              <a:ext cx="525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OST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8" name=""/>
          <p:cNvSpPr/>
          <p:nvPr/>
        </p:nvSpPr>
        <p:spPr>
          <a:xfrm>
            <a:off x="4648320" y="5207040"/>
            <a:ext cx="18396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3933720" y="1231920"/>
            <a:ext cx="1447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eclusterin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5790960" y="2011320"/>
            <a:ext cx="835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5 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5790240" y="2590920"/>
            <a:ext cx="921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63 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5790960" y="3200400"/>
            <a:ext cx="835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6 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5790960" y="3789360"/>
            <a:ext cx="835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3 gene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5524560" y="1066680"/>
            <a:ext cx="32767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Identification of node inclusive of genes uniquely upregulated in the imiquimod-treated EOT samples of each cohor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3657600" y="2133720"/>
            <a:ext cx="2057400" cy="0"/>
          </a:xfrm>
          <a:prstGeom prst="line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3657600" y="2732040"/>
            <a:ext cx="2057400" cy="0"/>
          </a:xfrm>
          <a:prstGeom prst="line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3657600" y="3330720"/>
            <a:ext cx="2057400" cy="0"/>
          </a:xfrm>
          <a:prstGeom prst="line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3657600" y="3930480"/>
            <a:ext cx="2057400" cy="0"/>
          </a:xfrm>
          <a:prstGeom prst="line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304920" y="364320"/>
            <a:ext cx="85341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iagram of Mining Strategy Summarizing Hierarchical Clustering Based on Genes Differentially Expressed at EOT Compared to Pre-Treatment Samples in Each Treatment Cohor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5788440" y="0"/>
            <a:ext cx="3271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material #4 for Figure 1C,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5816520" y="3733920"/>
            <a:ext cx="838440" cy="380880"/>
          </a:xfrm>
          <a:prstGeom prst="ellipse">
            <a:avLst/>
          </a:prstGeom>
          <a:noFill/>
          <a:ln w="9360">
            <a:solidFill>
              <a:srgbClr val="ffcc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5829480" y="2540160"/>
            <a:ext cx="838080" cy="380880"/>
          </a:xfrm>
          <a:prstGeom prst="ellipse">
            <a:avLst/>
          </a:prstGeom>
          <a:noFill/>
          <a:ln w="9360">
            <a:solidFill>
              <a:srgbClr val="33339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5816520" y="3124080"/>
            <a:ext cx="838440" cy="381240"/>
          </a:xfrm>
          <a:prstGeom prst="ellipse">
            <a:avLst/>
          </a:prstGeom>
          <a:noFill/>
          <a:ln w="9360">
            <a:solidFill>
              <a:srgbClr val="99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5791320" y="1981080"/>
            <a:ext cx="838080" cy="381240"/>
          </a:xfrm>
          <a:prstGeom prst="ellipse">
            <a:avLst/>
          </a:prstGeom>
          <a:noFill/>
          <a:ln w="936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5" name="" descr=""/>
          <p:cNvPicPr/>
          <p:nvPr/>
        </p:nvPicPr>
        <p:blipFill>
          <a:blip r:embed="rId1"/>
          <a:stretch/>
        </p:blipFill>
        <p:spPr>
          <a:xfrm>
            <a:off x="6986520" y="2209680"/>
            <a:ext cx="2119320" cy="20289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86" name=""/>
          <p:cNvSpPr/>
          <p:nvPr/>
        </p:nvSpPr>
        <p:spPr>
          <a:xfrm>
            <a:off x="6998040" y="1854360"/>
            <a:ext cx="199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Gene comparison and overla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304920" y="4952880"/>
            <a:ext cx="6400800" cy="459000"/>
          </a:xfrm>
          <a:prstGeom prst="rect">
            <a:avLst/>
          </a:prstGeom>
          <a:solidFill>
            <a:srgbClr val="bbe0e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ample Analysis of the Degree of Relatedness of Samples Based on Imiquimod-Induced Genes in The blue Group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762120" y="4406760"/>
            <a:ext cx="4724280" cy="276480"/>
          </a:xfrm>
          <a:prstGeom prst="rect">
            <a:avLst/>
          </a:prstGeom>
          <a:solidFill>
            <a:srgbClr val="bbe0e3"/>
          </a:solidFill>
          <a:ln w="9360">
            <a:solidFill>
              <a:srgbClr val="bbe0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Genes used to re-cluster orange, blue, green, pink cohort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9" name="" descr=""/>
          <p:cNvPicPr/>
          <p:nvPr/>
        </p:nvPicPr>
        <p:blipFill>
          <a:blip r:embed="rId2"/>
          <a:stretch/>
        </p:blipFill>
        <p:spPr>
          <a:xfrm>
            <a:off x="838080" y="5410080"/>
            <a:ext cx="4876920" cy="1325520"/>
          </a:xfrm>
          <a:prstGeom prst="rect">
            <a:avLst/>
          </a:prstGeom>
          <a:ln w="0">
            <a:noFill/>
          </a:ln>
        </p:spPr>
      </p:pic>
      <p:sp>
        <p:nvSpPr>
          <p:cNvPr id="90" name=""/>
          <p:cNvSpPr/>
          <p:nvPr/>
        </p:nvSpPr>
        <p:spPr>
          <a:xfrm>
            <a:off x="0" y="1676520"/>
            <a:ext cx="914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0" y="990720"/>
            <a:ext cx="914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2590920" y="4724280"/>
            <a:ext cx="0" cy="2286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0" y="4330800"/>
            <a:ext cx="9144000" cy="12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 flipH="1">
            <a:off x="2590560" y="2819520"/>
            <a:ext cx="3276360" cy="160020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  <p:timing>
    <p:tnLst>
      <p:par>
        <p:cTn id="1" dur="indefinite" restart="never" nodeType="tmRoot">
          <p:childTnLst>
            <p:seq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nodeType="clickEffect" fill="hold" presetClass="emph" presetID="6">
                                  <p:stCondLst>
                                    <p:cond delay="0"/>
                                  </p:stCondLst>
                                  <p:childTnLst>
                                    <p:animScale>
                                      <p:cBhvr>
                                        <p:cTn id="6" dur="500" fill="hold"/>
                                        <p:tgtEl>
                                          <p:spTgt spid="53"/>
                                        </p:tgtEl>
                                      </p:cBhvr>
                                      <p:to x="150000" y="150000"/>
                                    </p:animScale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>
                  <p:tgtEl>
                    <p:sldTgt/>
                  </p:tgtEl>
                </p:cond>
              </p:prevCondLst>
              <p:nextCondLst>
                <p:cond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7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2-02T16:18:39Z</dcterms:created>
  <dc:creator>Monica Panelli</dc:creator>
  <dc:description/>
  <dc:language>en-US</dc:language>
  <cp:lastModifiedBy>Monica Panelli</cp:lastModifiedBy>
  <dcterms:modified xsi:type="dcterms:W3CDTF">2006-12-03T00:10:10Z</dcterms:modified>
  <cp:revision>4</cp:revision>
  <dc:subject/>
  <dc:title>Slide 1</dc:title>
</cp:coreProperties>
</file>